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2" d="100"/>
          <a:sy n="62" d="100"/>
        </p:scale>
        <p:origin x="168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8376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815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72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548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677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62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38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80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399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2361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7382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44C5B-D191-4858-8E08-26EE30AE5732}" type="datetimeFigureOut">
              <a:rPr lang="en-GB" smtClean="0"/>
              <a:t>30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28A20-42E9-486D-9A0D-DC3B851DAE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7426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/>
          <p:cNvGrpSpPr/>
          <p:nvPr/>
        </p:nvGrpSpPr>
        <p:grpSpPr>
          <a:xfrm>
            <a:off x="455124" y="932309"/>
            <a:ext cx="5951887" cy="10466810"/>
            <a:chOff x="159849" y="884684"/>
            <a:chExt cx="5951887" cy="1046681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803" y="1550486"/>
              <a:ext cx="2222586" cy="177209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47138" y="1196462"/>
              <a:ext cx="11352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Control: 3m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59849" y="884684"/>
              <a:ext cx="48478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:  Representative images of Sudan Black B staining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944316" y="1196547"/>
              <a:ext cx="17588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Control: 3m (detailed)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97121" y="1534929"/>
              <a:ext cx="2311401" cy="1651045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10703" y="3529744"/>
              <a:ext cx="14879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 Recuperated (3m)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881017" y="3501542"/>
              <a:ext cx="2127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 Recuperated (3m) (detailed)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606" y="4015104"/>
              <a:ext cx="2242296" cy="182552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90074" y="3910473"/>
              <a:ext cx="2122145" cy="1891374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418488" y="6067894"/>
              <a:ext cx="12554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 Control (12m)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44316" y="6067894"/>
              <a:ext cx="18811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 Control (12m) (detailed)</a:t>
              </a:r>
            </a:p>
          </p:txBody>
        </p: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8488" y="6665559"/>
              <a:ext cx="2729874" cy="1936129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72833" y="6635742"/>
              <a:ext cx="2156626" cy="1847423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410703" y="8963369"/>
              <a:ext cx="1562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) Recuperated (12m)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903567" y="8897840"/>
              <a:ext cx="22081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) Recuperated (12m) (detailed)</a:t>
              </a: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8149" y="9517367"/>
              <a:ext cx="2706571" cy="1834127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0684" y="9485951"/>
              <a:ext cx="2188776" cy="1865543"/>
            </a:xfrm>
            <a:prstGeom prst="rect">
              <a:avLst/>
            </a:prstGeom>
          </p:spPr>
        </p:pic>
        <p:cxnSp>
          <p:nvCxnSpPr>
            <p:cNvPr id="25" name="Straight Arrow Connector 24"/>
            <p:cNvCxnSpPr/>
            <p:nvPr/>
          </p:nvCxnSpPr>
          <p:spPr>
            <a:xfrm flipH="1">
              <a:off x="3533614" y="8082089"/>
              <a:ext cx="1053884" cy="71292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2322793" y="7457650"/>
              <a:ext cx="862107" cy="127536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2248772" y="8810638"/>
              <a:ext cx="15919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nescent cell staining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" name="Straight Arrow Connector 29"/>
            <p:cNvCxnSpPr/>
            <p:nvPr/>
          </p:nvCxnSpPr>
          <p:spPr>
            <a:xfrm flipH="1" flipV="1">
              <a:off x="3533615" y="9153167"/>
              <a:ext cx="1474036" cy="95538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 flipH="1" flipV="1">
              <a:off x="3351797" y="9174840"/>
              <a:ext cx="1599349" cy="142550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>
              <a:endCxn id="28" idx="2"/>
            </p:cNvCxnSpPr>
            <p:nvPr/>
          </p:nvCxnSpPr>
          <p:spPr>
            <a:xfrm flipV="1">
              <a:off x="2065684" y="9087637"/>
              <a:ext cx="979044" cy="81393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2065684" y="5253925"/>
              <a:ext cx="514218" cy="74206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2229918" y="5999757"/>
              <a:ext cx="1495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 specific staining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8" name="Straight Arrow Connector 47"/>
            <p:cNvCxnSpPr/>
            <p:nvPr/>
          </p:nvCxnSpPr>
          <p:spPr>
            <a:xfrm flipV="1">
              <a:off x="933450" y="6270357"/>
              <a:ext cx="1486228" cy="89946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 flipV="1">
              <a:off x="2035938" y="9105984"/>
              <a:ext cx="362705" cy="70336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>
              <a:endCxn id="28" idx="0"/>
            </p:cNvCxnSpPr>
            <p:nvPr/>
          </p:nvCxnSpPr>
          <p:spPr>
            <a:xfrm>
              <a:off x="2035938" y="7653264"/>
              <a:ext cx="1008790" cy="115737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H="1">
              <a:off x="3404867" y="7417552"/>
              <a:ext cx="1180996" cy="122146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94176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75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Jane Adkins</cp:lastModifiedBy>
  <cp:revision>6</cp:revision>
  <cp:lastPrinted>2018-05-16T05:38:22Z</cp:lastPrinted>
  <dcterms:created xsi:type="dcterms:W3CDTF">2018-05-14T06:02:22Z</dcterms:created>
  <dcterms:modified xsi:type="dcterms:W3CDTF">2018-05-30T06:15:05Z</dcterms:modified>
</cp:coreProperties>
</file>